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CC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185" autoAdjust="0"/>
    <p:restoredTop sz="94660"/>
  </p:normalViewPr>
  <p:slideViewPr>
    <p:cSldViewPr snapToGrid="0">
      <p:cViewPr>
        <p:scale>
          <a:sx n="200" d="100"/>
          <a:sy n="200" d="100"/>
        </p:scale>
        <p:origin x="834" y="33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679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8874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72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281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993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19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643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54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008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8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951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050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872" y="3383583"/>
            <a:ext cx="3370363" cy="136539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911418" y="3402907"/>
            <a:ext cx="2515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W     FG     FGD    FG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1987791" y="3396566"/>
            <a:ext cx="1165350" cy="28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3287214" y="3396567"/>
            <a:ext cx="2818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2255163" y="3114493"/>
            <a:ext cx="22006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etal             Leaf               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3684561" y="3353453"/>
            <a:ext cx="1211047" cy="14415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/>
          <p:cNvSpPr/>
          <p:nvPr/>
        </p:nvSpPr>
        <p:spPr>
          <a:xfrm>
            <a:off x="1347644" y="3370869"/>
            <a:ext cx="563774" cy="1654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608284" y="3631964"/>
            <a:ext cx="2028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MYB113-like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(IABW1054620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13047" y="3812612"/>
            <a:ext cx="15905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ANS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IABW01131358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600282" y="3998022"/>
            <a:ext cx="15424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CHI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IABW01015168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598540" y="4180184"/>
            <a:ext cx="15985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CHS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IABW01129582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611495" y="4367109"/>
            <a:ext cx="15905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DFR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IABW01014032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1557273" y="4628719"/>
            <a:ext cx="2166938" cy="1441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146697" y="8460328"/>
            <a:ext cx="4316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ditional file 5: Figure S3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6816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6</TotalTime>
  <Words>33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miya14</dc:creator>
  <cp:lastModifiedBy>Balindan, Danica Joy</cp:lastModifiedBy>
  <cp:revision>66</cp:revision>
  <cp:lastPrinted>2017-07-03T02:06:04Z</cp:lastPrinted>
  <dcterms:created xsi:type="dcterms:W3CDTF">2015-04-13T07:25:54Z</dcterms:created>
  <dcterms:modified xsi:type="dcterms:W3CDTF">2017-11-13T05:40:22Z</dcterms:modified>
</cp:coreProperties>
</file>